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82E818-9753-40DF-91D0-9E8A0E2111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44E9A2C-F381-4C78-A560-000E51B707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0CD5A8-289D-40FD-BFB7-28A6EEDD8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FEB90-74C8-4991-8496-E95E11DA317C}" type="datetimeFigureOut">
              <a:rPr lang="en-AU" smtClean="0"/>
              <a:t>6/05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03E1BF-7B31-43EB-B629-3FF18B73E7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BAA9D0-8550-4092-A3FB-5C91CCFDD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60D71-6277-4FEC-88B8-F62A0268DB5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79668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BCC993-B8F4-4BAB-BC50-476D684472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0730D5-5DDD-415A-93D9-6CB90BBCA4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4B45A7-4719-4CCF-B4A7-532C6E4E0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FEB90-74C8-4991-8496-E95E11DA317C}" type="datetimeFigureOut">
              <a:rPr lang="en-AU" smtClean="0"/>
              <a:t>6/05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CF9CB1-71D4-46B3-8C13-EE6DB29CDE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006332-CD33-4227-BBE1-539F530ED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60D71-6277-4FEC-88B8-F62A0268DB5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42482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889EB57-1AD3-4558-AE16-59731900B6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C8C4C6-FCA2-4E45-884D-CF5F4CF99C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13E3C0-8023-4500-B616-531301EA4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FEB90-74C8-4991-8496-E95E11DA317C}" type="datetimeFigureOut">
              <a:rPr lang="en-AU" smtClean="0"/>
              <a:t>6/05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4FC736-76B9-4868-B3B9-431567FFA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765512-73A8-4DA4-BB76-193933C7E6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60D71-6277-4FEC-88B8-F62A0268DB5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232959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1479B4-F512-477F-A2E2-BF141E55D0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6F24DE-F660-483C-8F3A-36D04DD894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F1E776-5B67-4FD5-8755-8D4CA6092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FEB90-74C8-4991-8496-E95E11DA317C}" type="datetimeFigureOut">
              <a:rPr lang="en-AU" smtClean="0"/>
              <a:t>6/05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8B9C95-DBB7-4F5A-BD91-7AA924C567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2E56D5-5B03-4FBE-89D1-48E56643DF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60D71-6277-4FEC-88B8-F62A0268DB5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50491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364384-473A-4058-AA11-F9B3544274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C4AC80-5BFE-42D5-A22F-53101375EB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2EF8DA-5321-4E7A-A3DC-E49E2036B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FEB90-74C8-4991-8496-E95E11DA317C}" type="datetimeFigureOut">
              <a:rPr lang="en-AU" smtClean="0"/>
              <a:t>6/05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255834-04FB-436A-A810-10901AF39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FA79E7-3C99-4ED4-97A9-0877C5EECC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60D71-6277-4FEC-88B8-F62A0268DB5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24117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45CF17-4E4E-421B-BD20-AC1C9469BC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83C635-FE39-4406-AFC9-68DB247B5F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FFBE15-BBDB-4A8C-9D6B-3AC6EFEE87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DC7B58-8FD5-44BB-B298-61CC26DF6F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FEB90-74C8-4991-8496-E95E11DA317C}" type="datetimeFigureOut">
              <a:rPr lang="en-AU" smtClean="0"/>
              <a:t>6/05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2869FB-406E-4C37-ACBC-F739A31AAC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9BADB9-1866-4BA6-8772-48B73B7033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60D71-6277-4FEC-88B8-F62A0268DB5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85140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E4FFD0-0C16-4129-84F7-3A7CB32C20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D3F2DD-4E34-495C-93B8-38949807FE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67BF42-16AD-428F-857E-57FB13B9C6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0BE8A5-9FFE-4323-851F-CE40918874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A0FF5BE-80D6-4D92-B1BF-8249F2915B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DA80E26-7DE1-4873-BC92-6FE471403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FEB90-74C8-4991-8496-E95E11DA317C}" type="datetimeFigureOut">
              <a:rPr lang="en-AU" smtClean="0"/>
              <a:t>6/05/2020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6EE8C52-3155-4804-A4AF-34CE5E8E1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3FE5CF3-5D78-4EB0-A0E4-A351136EB0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60D71-6277-4FEC-88B8-F62A0268DB5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3533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3926A2-8284-4C00-A39F-9CD0144B3E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49EF3C4-70CE-4F28-AE34-8EC595801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FEB90-74C8-4991-8496-E95E11DA317C}" type="datetimeFigureOut">
              <a:rPr lang="en-AU" smtClean="0"/>
              <a:t>6/05/2020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C064BBC-AC03-4CC2-A905-128F5E1C1C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13F0872-25FD-489C-B980-FEA2F50F72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60D71-6277-4FEC-88B8-F62A0268DB5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77915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3AD51F6-4E80-44B2-BB98-99B3109B1A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FEB90-74C8-4991-8496-E95E11DA317C}" type="datetimeFigureOut">
              <a:rPr lang="en-AU" smtClean="0"/>
              <a:t>6/05/2020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843942D-97F7-434D-BE5F-A16F3D722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A637CA9-BBD8-40B1-9434-69F2CF44E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60D71-6277-4FEC-88B8-F62A0268DB5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82085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1B188A-F159-48B0-88D3-B59F216E24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D8FE1A-3CF4-428D-A4D5-FDE7BA0C95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91822D-D989-4279-BCCF-0BBD1F1F2A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FB1E9F-D7C5-412F-B448-610649BB2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FEB90-74C8-4991-8496-E95E11DA317C}" type="datetimeFigureOut">
              <a:rPr lang="en-AU" smtClean="0"/>
              <a:t>6/05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5A9CEA-C746-4CE3-9F90-3EC4947AC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E9FF6D-1570-427D-862D-C3276B70A3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60D71-6277-4FEC-88B8-F62A0268DB5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6917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249DD7-5FBF-41BB-9233-CF1C6783E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77C464C-0D78-4B0D-9DA2-09958C121D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FF3F07-4B96-4BCA-8411-9D3778EA8A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3C9455-AC95-493F-A1FF-A8CF9B91CA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FEB90-74C8-4991-8496-E95E11DA317C}" type="datetimeFigureOut">
              <a:rPr lang="en-AU" smtClean="0"/>
              <a:t>6/05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7AD0BC-3CAF-4031-81A2-4C490321E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326105-92C1-407B-B521-52925065D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960D71-6277-4FEC-88B8-F62A0268DB5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66850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9FBE54-0C1F-4ADF-B0F9-497B9F29CE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935937-D021-4138-AAF9-FDA397A73D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2A3238-FEAB-4A49-A20C-42D42D80A2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FEB90-74C8-4991-8496-E95E11DA317C}" type="datetimeFigureOut">
              <a:rPr lang="en-AU" smtClean="0"/>
              <a:t>6/05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BA53B1-4715-44DC-8DEC-A8463348B9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3027E6-016B-4739-87AE-50169CF049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960D71-6277-4FEC-88B8-F62A0268DB5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71171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207B560-FEF7-4845-A211-5D5969CF7078}"/>
              </a:ext>
            </a:extLst>
          </p:cNvPr>
          <p:cNvGrpSpPr/>
          <p:nvPr/>
        </p:nvGrpSpPr>
        <p:grpSpPr>
          <a:xfrm>
            <a:off x="8027437" y="293321"/>
            <a:ext cx="3891195" cy="923330"/>
            <a:chOff x="6947382" y="297205"/>
            <a:chExt cx="3891195" cy="923330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33B2F7A-AFF1-4F38-988C-A6D5538C03FD}"/>
                </a:ext>
              </a:extLst>
            </p:cNvPr>
            <p:cNvSpPr txBox="1"/>
            <p:nvPr/>
          </p:nvSpPr>
          <p:spPr>
            <a:xfrm>
              <a:off x="7188639" y="297205"/>
              <a:ext cx="3649938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NCBI database of complete genomes</a:t>
              </a:r>
            </a:p>
            <a:p>
              <a:r>
                <a:rPr lang="en-AU" dirty="0"/>
                <a:t>This study</a:t>
              </a:r>
              <a:endParaRPr lang="en-AU" dirty="0">
                <a:highlight>
                  <a:srgbClr val="FFFF00"/>
                </a:highlight>
              </a:endParaRPr>
            </a:p>
            <a:p>
              <a:r>
                <a:rPr lang="en-AU" dirty="0"/>
                <a:t>Davies GAS atlas</a:t>
              </a:r>
              <a:endParaRPr lang="en-AU" dirty="0">
                <a:highlight>
                  <a:srgbClr val="FFFF00"/>
                </a:highlight>
              </a:endParaRPr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84982518-C866-4EEE-A3C7-4AEF14F1248D}"/>
                </a:ext>
              </a:extLst>
            </p:cNvPr>
            <p:cNvSpPr/>
            <p:nvPr/>
          </p:nvSpPr>
          <p:spPr>
            <a:xfrm>
              <a:off x="6947382" y="946751"/>
              <a:ext cx="234282" cy="243683"/>
            </a:xfrm>
            <a:prstGeom prst="ellipse">
              <a:avLst/>
            </a:prstGeom>
            <a:solidFill>
              <a:schemeClr val="bg1">
                <a:alpha val="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462469F7-291B-4DDC-AFAD-9642D5F300A2}"/>
                </a:ext>
              </a:extLst>
            </p:cNvPr>
            <p:cNvSpPr/>
            <p:nvPr/>
          </p:nvSpPr>
          <p:spPr>
            <a:xfrm>
              <a:off x="6954357" y="646403"/>
              <a:ext cx="234282" cy="243683"/>
            </a:xfrm>
            <a:prstGeom prst="ellipse">
              <a:avLst/>
            </a:prstGeom>
            <a:solidFill>
              <a:srgbClr val="FFFF00">
                <a:alpha val="18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4" name="Oval 13">
              <a:extLst>
                <a:ext uri="{FF2B5EF4-FFF2-40B4-BE49-F238E27FC236}">
                  <a16:creationId xmlns:a16="http://schemas.microsoft.com/office/drawing/2014/main" id="{758CA3F7-D46D-4C3F-98BE-232F8900AFD2}"/>
                </a:ext>
              </a:extLst>
            </p:cNvPr>
            <p:cNvSpPr/>
            <p:nvPr/>
          </p:nvSpPr>
          <p:spPr>
            <a:xfrm>
              <a:off x="6954356" y="337108"/>
              <a:ext cx="234282" cy="243683"/>
            </a:xfrm>
            <a:prstGeom prst="ellipse">
              <a:avLst/>
            </a:prstGeom>
            <a:solidFill>
              <a:schemeClr val="accent1">
                <a:alpha val="23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F1EACA05-DB4F-40C1-8EFD-7EA98D15E4EA}"/>
              </a:ext>
            </a:extLst>
          </p:cNvPr>
          <p:cNvGrpSpPr/>
          <p:nvPr/>
        </p:nvGrpSpPr>
        <p:grpSpPr>
          <a:xfrm>
            <a:off x="2628264" y="886202"/>
            <a:ext cx="4872677" cy="4203261"/>
            <a:chOff x="1376335" y="826316"/>
            <a:chExt cx="4872677" cy="4203261"/>
          </a:xfrm>
        </p:grpSpPr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9D32AE8E-C480-4819-A9D0-BE9942B8F63B}"/>
                </a:ext>
              </a:extLst>
            </p:cNvPr>
            <p:cNvSpPr/>
            <p:nvPr/>
          </p:nvSpPr>
          <p:spPr>
            <a:xfrm>
              <a:off x="2004596" y="2069819"/>
              <a:ext cx="3187817" cy="2959758"/>
            </a:xfrm>
            <a:prstGeom prst="ellipse">
              <a:avLst/>
            </a:prstGeom>
            <a:solidFill>
              <a:schemeClr val="tx2">
                <a:alpha val="32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4D4665AF-6CBC-4121-AF42-FC26C98326AD}"/>
                </a:ext>
              </a:extLst>
            </p:cNvPr>
            <p:cNvSpPr/>
            <p:nvPr/>
          </p:nvSpPr>
          <p:spPr>
            <a:xfrm>
              <a:off x="2908183" y="1055893"/>
              <a:ext cx="3187817" cy="2959758"/>
            </a:xfrm>
            <a:prstGeom prst="ellipse">
              <a:avLst/>
            </a:prstGeom>
            <a:solidFill>
              <a:srgbClr val="FFFF00">
                <a:alpha val="16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6B1D1BB6-CCB0-44AE-A8B0-DE664B72C956}"/>
                </a:ext>
              </a:extLst>
            </p:cNvPr>
            <p:cNvSpPr/>
            <p:nvPr/>
          </p:nvSpPr>
          <p:spPr>
            <a:xfrm>
              <a:off x="1376335" y="826316"/>
              <a:ext cx="3187817" cy="2959758"/>
            </a:xfrm>
            <a:prstGeom prst="ellipse">
              <a:avLst/>
            </a:prstGeom>
            <a:solidFill>
              <a:schemeClr val="bg1">
                <a:alpha val="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4395BF4-3178-4C42-B877-E44012C80C4C}"/>
                </a:ext>
              </a:extLst>
            </p:cNvPr>
            <p:cNvSpPr txBox="1"/>
            <p:nvPr/>
          </p:nvSpPr>
          <p:spPr>
            <a:xfrm>
              <a:off x="3477207" y="2591964"/>
              <a:ext cx="10869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56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D89F604-C586-498A-B015-7F16EC9AAA81}"/>
                </a:ext>
              </a:extLst>
            </p:cNvPr>
            <p:cNvSpPr txBox="1"/>
            <p:nvPr/>
          </p:nvSpPr>
          <p:spPr>
            <a:xfrm>
              <a:off x="5162067" y="1938418"/>
              <a:ext cx="10869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C1DF342-1DFF-4482-A6B6-9B80C47C60AE}"/>
                </a:ext>
              </a:extLst>
            </p:cNvPr>
            <p:cNvSpPr txBox="1"/>
            <p:nvPr/>
          </p:nvSpPr>
          <p:spPr>
            <a:xfrm>
              <a:off x="3304663" y="4108371"/>
              <a:ext cx="10869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AB421EC-E0B9-4547-A997-36503753CC9F}"/>
                </a:ext>
              </a:extLst>
            </p:cNvPr>
            <p:cNvSpPr txBox="1"/>
            <p:nvPr/>
          </p:nvSpPr>
          <p:spPr>
            <a:xfrm>
              <a:off x="2104124" y="1569086"/>
              <a:ext cx="10869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22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D78C35D-EBFB-4227-8D02-749F0A4C9675}"/>
                </a:ext>
              </a:extLst>
            </p:cNvPr>
            <p:cNvSpPr txBox="1"/>
            <p:nvPr/>
          </p:nvSpPr>
          <p:spPr>
            <a:xfrm>
              <a:off x="4472473" y="3165979"/>
              <a:ext cx="10869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CD2FEE7-8DEE-4F35-8C21-757D9E0FEEE2}"/>
                </a:ext>
              </a:extLst>
            </p:cNvPr>
            <p:cNvSpPr txBox="1"/>
            <p:nvPr/>
          </p:nvSpPr>
          <p:spPr>
            <a:xfrm>
              <a:off x="3551183" y="1582520"/>
              <a:ext cx="10869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69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1BC2E13-BF21-41BB-A3E4-6CED66ABB86C}"/>
                </a:ext>
              </a:extLst>
            </p:cNvPr>
            <p:cNvSpPr txBox="1"/>
            <p:nvPr/>
          </p:nvSpPr>
          <p:spPr>
            <a:xfrm>
              <a:off x="2464238" y="2981313"/>
              <a:ext cx="10869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/>
                <a:t>2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3FF154BF-D657-4EB7-B9B0-464075F9F7C3}"/>
              </a:ext>
            </a:extLst>
          </p:cNvPr>
          <p:cNvSpPr txBox="1"/>
          <p:nvPr/>
        </p:nvSpPr>
        <p:spPr>
          <a:xfrm>
            <a:off x="894304" y="3476628"/>
            <a:ext cx="2029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i="1" dirty="0"/>
              <a:t>emm168, emm197 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B80F2465-7590-4732-9CF4-8024DD6657F6}"/>
              </a:ext>
            </a:extLst>
          </p:cNvPr>
          <p:cNvCxnSpPr>
            <a:stCxn id="21" idx="1"/>
            <a:endCxn id="22" idx="3"/>
          </p:cNvCxnSpPr>
          <p:nvPr/>
        </p:nvCxnSpPr>
        <p:spPr>
          <a:xfrm flipH="1">
            <a:off x="2923528" y="3225865"/>
            <a:ext cx="792639" cy="4354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B61F2556-A604-4BB7-95E0-7B76A3743897}"/>
              </a:ext>
            </a:extLst>
          </p:cNvPr>
          <p:cNvSpPr txBox="1"/>
          <p:nvPr/>
        </p:nvSpPr>
        <p:spPr>
          <a:xfrm>
            <a:off x="1720279" y="4572788"/>
            <a:ext cx="2029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i="1" dirty="0"/>
              <a:t>emm67 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A3F26E0B-8A5E-45FE-9D68-97EA802E94A5}"/>
              </a:ext>
            </a:extLst>
          </p:cNvPr>
          <p:cNvCxnSpPr>
            <a:cxnSpLocks/>
            <a:stCxn id="17" idx="1"/>
          </p:cNvCxnSpPr>
          <p:nvPr/>
        </p:nvCxnSpPr>
        <p:spPr>
          <a:xfrm flipH="1">
            <a:off x="2734891" y="4352923"/>
            <a:ext cx="1821701" cy="31606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850A4ED9-39AD-4FF0-AF61-4B786602EFBA}"/>
              </a:ext>
            </a:extLst>
          </p:cNvPr>
          <p:cNvSpPr txBox="1"/>
          <p:nvPr/>
        </p:nvSpPr>
        <p:spPr>
          <a:xfrm>
            <a:off x="399538" y="5554402"/>
            <a:ext cx="115190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S2: Distribution of </a:t>
            </a:r>
            <a:r>
              <a:rPr lang="en-AU" i="1" dirty="0" err="1"/>
              <a:t>emm</a:t>
            </a:r>
            <a:r>
              <a:rPr lang="en-AU" dirty="0"/>
              <a:t>-types within this study (n=125), the NCBI database of complete genomes as at 11-3-2020 (n=59), and the Davies GAS atlas (n=149</a:t>
            </a:r>
            <a:r>
              <a:rPr lang="en-AU"/>
              <a:t>) [11].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635222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61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an Buckley</dc:creator>
  <cp:lastModifiedBy>Sean Buckley</cp:lastModifiedBy>
  <cp:revision>8</cp:revision>
  <dcterms:created xsi:type="dcterms:W3CDTF">2020-03-11T02:48:38Z</dcterms:created>
  <dcterms:modified xsi:type="dcterms:W3CDTF">2020-05-06T07:23:29Z</dcterms:modified>
</cp:coreProperties>
</file>